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33" autoAdjust="0"/>
    <p:restoredTop sz="96076" autoAdjust="0"/>
  </p:normalViewPr>
  <p:slideViewPr>
    <p:cSldViewPr snapToGrid="0">
      <p:cViewPr>
        <p:scale>
          <a:sx n="70" d="100"/>
          <a:sy n="70" d="100"/>
        </p:scale>
        <p:origin x="2460" y="-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5078720F-D5BF-FD1C-FE1A-D99496099F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0402" y="2218288"/>
            <a:ext cx="4102799" cy="4582562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D0CA0CA-1030-49B8-A9E8-A0177FDACF71}"/>
              </a:ext>
            </a:extLst>
          </p:cNvPr>
          <p:cNvSpPr/>
          <p:nvPr/>
        </p:nvSpPr>
        <p:spPr>
          <a:xfrm>
            <a:off x="521367" y="7326235"/>
            <a:ext cx="5815265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 file 6: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pact of KNO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ment on the growth of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brassicicol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t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mL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ea under the curve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brassicicola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strain Ab43) without (Ct) and with the addition of KNO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[30mM] diluted to 10%. n=1 and p</a:t>
            </a:r>
            <a:r>
              <a:rPr lang="en-GB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ints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box plots corresponds of the three technical replicates (n)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star indicates a significant difference from control (t-test, p&lt;0.05). No statistical difference was found.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74857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1</TotalTime>
  <Words>93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13</cp:revision>
  <dcterms:created xsi:type="dcterms:W3CDTF">2023-08-10T14:53:51Z</dcterms:created>
  <dcterms:modified xsi:type="dcterms:W3CDTF">2024-01-17T14:37:05Z</dcterms:modified>
</cp:coreProperties>
</file>